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1160125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2" autoAdjust="0"/>
    <p:restoredTop sz="94660"/>
  </p:normalViewPr>
  <p:slideViewPr>
    <p:cSldViewPr snapToGrid="0">
      <p:cViewPr varScale="1">
        <p:scale>
          <a:sx n="63" d="100"/>
          <a:sy n="63" d="100"/>
        </p:scale>
        <p:origin x="166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7010" y="1414125"/>
            <a:ext cx="9486106" cy="3008266"/>
          </a:xfrm>
        </p:spPr>
        <p:txBody>
          <a:bodyPr anchor="b"/>
          <a:lstStyle>
            <a:lvl1pPr algn="ctr">
              <a:defRPr sz="7323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95016" y="4538401"/>
            <a:ext cx="8370094" cy="2086184"/>
          </a:xfrm>
        </p:spPr>
        <p:txBody>
          <a:bodyPr/>
          <a:lstStyle>
            <a:lvl1pPr marL="0" indent="0" algn="ctr">
              <a:buNone/>
              <a:defRPr sz="2929"/>
            </a:lvl1pPr>
            <a:lvl2pPr marL="558013" indent="0" algn="ctr">
              <a:buNone/>
              <a:defRPr sz="2441"/>
            </a:lvl2pPr>
            <a:lvl3pPr marL="1116025" indent="0" algn="ctr">
              <a:buNone/>
              <a:defRPr sz="2197"/>
            </a:lvl3pPr>
            <a:lvl4pPr marL="1674038" indent="0" algn="ctr">
              <a:buNone/>
              <a:defRPr sz="1953"/>
            </a:lvl4pPr>
            <a:lvl5pPr marL="2232050" indent="0" algn="ctr">
              <a:buNone/>
              <a:defRPr sz="1953"/>
            </a:lvl5pPr>
            <a:lvl6pPr marL="2790063" indent="0" algn="ctr">
              <a:buNone/>
              <a:defRPr sz="1953"/>
            </a:lvl6pPr>
            <a:lvl7pPr marL="3348076" indent="0" algn="ctr">
              <a:buNone/>
              <a:defRPr sz="1953"/>
            </a:lvl7pPr>
            <a:lvl8pPr marL="3906088" indent="0" algn="ctr">
              <a:buNone/>
              <a:defRPr sz="1953"/>
            </a:lvl8pPr>
            <a:lvl9pPr marL="4464101" indent="0" algn="ctr">
              <a:buNone/>
              <a:defRPr sz="195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942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1178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86465" y="460041"/>
            <a:ext cx="2406402" cy="732264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67259" y="460041"/>
            <a:ext cx="7079704" cy="732264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2509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9865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447" y="2154193"/>
            <a:ext cx="9625608" cy="3594317"/>
          </a:xfrm>
        </p:spPr>
        <p:txBody>
          <a:bodyPr anchor="b"/>
          <a:lstStyle>
            <a:lvl1pPr>
              <a:defRPr sz="7323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1447" y="5782513"/>
            <a:ext cx="9625608" cy="1890166"/>
          </a:xfrm>
        </p:spPr>
        <p:txBody>
          <a:bodyPr/>
          <a:lstStyle>
            <a:lvl1pPr marL="0" indent="0">
              <a:buNone/>
              <a:defRPr sz="2929">
                <a:solidFill>
                  <a:schemeClr val="tx1"/>
                </a:solidFill>
              </a:defRPr>
            </a:lvl1pPr>
            <a:lvl2pPr marL="558013" indent="0">
              <a:buNone/>
              <a:defRPr sz="2441">
                <a:solidFill>
                  <a:schemeClr val="tx1">
                    <a:tint val="75000"/>
                  </a:schemeClr>
                </a:solidFill>
              </a:defRPr>
            </a:lvl2pPr>
            <a:lvl3pPr marL="1116025" indent="0">
              <a:buNone/>
              <a:defRPr sz="2197">
                <a:solidFill>
                  <a:schemeClr val="tx1">
                    <a:tint val="75000"/>
                  </a:schemeClr>
                </a:solidFill>
              </a:defRPr>
            </a:lvl3pPr>
            <a:lvl4pPr marL="1674038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4pPr>
            <a:lvl5pPr marL="2232050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5pPr>
            <a:lvl6pPr marL="2790063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6pPr>
            <a:lvl7pPr marL="3348076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7pPr>
            <a:lvl8pPr marL="3906088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8pPr>
            <a:lvl9pPr marL="4464101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8591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7259" y="2300203"/>
            <a:ext cx="4743053" cy="54824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49813" y="2300203"/>
            <a:ext cx="4743053" cy="54824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5477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712" y="460043"/>
            <a:ext cx="9625608" cy="167014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8714" y="2118188"/>
            <a:ext cx="4721255" cy="1038091"/>
          </a:xfrm>
        </p:spPr>
        <p:txBody>
          <a:bodyPr anchor="b"/>
          <a:lstStyle>
            <a:lvl1pPr marL="0" indent="0">
              <a:buNone/>
              <a:defRPr sz="2929" b="1"/>
            </a:lvl1pPr>
            <a:lvl2pPr marL="558013" indent="0">
              <a:buNone/>
              <a:defRPr sz="2441" b="1"/>
            </a:lvl2pPr>
            <a:lvl3pPr marL="1116025" indent="0">
              <a:buNone/>
              <a:defRPr sz="2197" b="1"/>
            </a:lvl3pPr>
            <a:lvl4pPr marL="1674038" indent="0">
              <a:buNone/>
              <a:defRPr sz="1953" b="1"/>
            </a:lvl4pPr>
            <a:lvl5pPr marL="2232050" indent="0">
              <a:buNone/>
              <a:defRPr sz="1953" b="1"/>
            </a:lvl5pPr>
            <a:lvl6pPr marL="2790063" indent="0">
              <a:buNone/>
              <a:defRPr sz="1953" b="1"/>
            </a:lvl6pPr>
            <a:lvl7pPr marL="3348076" indent="0">
              <a:buNone/>
              <a:defRPr sz="1953" b="1"/>
            </a:lvl7pPr>
            <a:lvl8pPr marL="3906088" indent="0">
              <a:buNone/>
              <a:defRPr sz="1953" b="1"/>
            </a:lvl8pPr>
            <a:lvl9pPr marL="4464101" indent="0">
              <a:buNone/>
              <a:defRPr sz="195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8714" y="3156278"/>
            <a:ext cx="4721255" cy="464241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49814" y="2118188"/>
            <a:ext cx="4744507" cy="1038091"/>
          </a:xfrm>
        </p:spPr>
        <p:txBody>
          <a:bodyPr anchor="b"/>
          <a:lstStyle>
            <a:lvl1pPr marL="0" indent="0">
              <a:buNone/>
              <a:defRPr sz="2929" b="1"/>
            </a:lvl1pPr>
            <a:lvl2pPr marL="558013" indent="0">
              <a:buNone/>
              <a:defRPr sz="2441" b="1"/>
            </a:lvl2pPr>
            <a:lvl3pPr marL="1116025" indent="0">
              <a:buNone/>
              <a:defRPr sz="2197" b="1"/>
            </a:lvl3pPr>
            <a:lvl4pPr marL="1674038" indent="0">
              <a:buNone/>
              <a:defRPr sz="1953" b="1"/>
            </a:lvl4pPr>
            <a:lvl5pPr marL="2232050" indent="0">
              <a:buNone/>
              <a:defRPr sz="1953" b="1"/>
            </a:lvl5pPr>
            <a:lvl6pPr marL="2790063" indent="0">
              <a:buNone/>
              <a:defRPr sz="1953" b="1"/>
            </a:lvl6pPr>
            <a:lvl7pPr marL="3348076" indent="0">
              <a:buNone/>
              <a:defRPr sz="1953" b="1"/>
            </a:lvl7pPr>
            <a:lvl8pPr marL="3906088" indent="0">
              <a:buNone/>
              <a:defRPr sz="1953" b="1"/>
            </a:lvl8pPr>
            <a:lvl9pPr marL="4464101" indent="0">
              <a:buNone/>
              <a:defRPr sz="195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49814" y="3156278"/>
            <a:ext cx="4744507" cy="464241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8660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481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8347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712" y="576051"/>
            <a:ext cx="3599431" cy="2016178"/>
          </a:xfrm>
        </p:spPr>
        <p:txBody>
          <a:bodyPr anchor="b"/>
          <a:lstStyle>
            <a:lvl1pPr>
              <a:defRPr sz="390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44507" y="1244112"/>
            <a:ext cx="5649813" cy="6140542"/>
          </a:xfrm>
        </p:spPr>
        <p:txBody>
          <a:bodyPr/>
          <a:lstStyle>
            <a:lvl1pPr>
              <a:defRPr sz="3906"/>
            </a:lvl1pPr>
            <a:lvl2pPr>
              <a:defRPr sz="3417"/>
            </a:lvl2pPr>
            <a:lvl3pPr>
              <a:defRPr sz="2929"/>
            </a:lvl3pPr>
            <a:lvl4pPr>
              <a:defRPr sz="2441"/>
            </a:lvl4pPr>
            <a:lvl5pPr>
              <a:defRPr sz="2441"/>
            </a:lvl5pPr>
            <a:lvl6pPr>
              <a:defRPr sz="2441"/>
            </a:lvl6pPr>
            <a:lvl7pPr>
              <a:defRPr sz="2441"/>
            </a:lvl7pPr>
            <a:lvl8pPr>
              <a:defRPr sz="2441"/>
            </a:lvl8pPr>
            <a:lvl9pPr>
              <a:defRPr sz="244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8712" y="2592229"/>
            <a:ext cx="3599431" cy="4802425"/>
          </a:xfrm>
        </p:spPr>
        <p:txBody>
          <a:bodyPr/>
          <a:lstStyle>
            <a:lvl1pPr marL="0" indent="0">
              <a:buNone/>
              <a:defRPr sz="1953"/>
            </a:lvl1pPr>
            <a:lvl2pPr marL="558013" indent="0">
              <a:buNone/>
              <a:defRPr sz="1709"/>
            </a:lvl2pPr>
            <a:lvl3pPr marL="1116025" indent="0">
              <a:buNone/>
              <a:defRPr sz="1465"/>
            </a:lvl3pPr>
            <a:lvl4pPr marL="1674038" indent="0">
              <a:buNone/>
              <a:defRPr sz="1221"/>
            </a:lvl4pPr>
            <a:lvl5pPr marL="2232050" indent="0">
              <a:buNone/>
              <a:defRPr sz="1221"/>
            </a:lvl5pPr>
            <a:lvl6pPr marL="2790063" indent="0">
              <a:buNone/>
              <a:defRPr sz="1221"/>
            </a:lvl6pPr>
            <a:lvl7pPr marL="3348076" indent="0">
              <a:buNone/>
              <a:defRPr sz="1221"/>
            </a:lvl7pPr>
            <a:lvl8pPr marL="3906088" indent="0">
              <a:buNone/>
              <a:defRPr sz="1221"/>
            </a:lvl8pPr>
            <a:lvl9pPr marL="4464101" indent="0">
              <a:buNone/>
              <a:defRPr sz="122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466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712" y="576051"/>
            <a:ext cx="3599431" cy="2016178"/>
          </a:xfrm>
        </p:spPr>
        <p:txBody>
          <a:bodyPr anchor="b"/>
          <a:lstStyle>
            <a:lvl1pPr>
              <a:defRPr sz="390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44507" y="1244112"/>
            <a:ext cx="5649813" cy="6140542"/>
          </a:xfrm>
        </p:spPr>
        <p:txBody>
          <a:bodyPr anchor="t"/>
          <a:lstStyle>
            <a:lvl1pPr marL="0" indent="0">
              <a:buNone/>
              <a:defRPr sz="3906"/>
            </a:lvl1pPr>
            <a:lvl2pPr marL="558013" indent="0">
              <a:buNone/>
              <a:defRPr sz="3417"/>
            </a:lvl2pPr>
            <a:lvl3pPr marL="1116025" indent="0">
              <a:buNone/>
              <a:defRPr sz="2929"/>
            </a:lvl3pPr>
            <a:lvl4pPr marL="1674038" indent="0">
              <a:buNone/>
              <a:defRPr sz="2441"/>
            </a:lvl4pPr>
            <a:lvl5pPr marL="2232050" indent="0">
              <a:buNone/>
              <a:defRPr sz="2441"/>
            </a:lvl5pPr>
            <a:lvl6pPr marL="2790063" indent="0">
              <a:buNone/>
              <a:defRPr sz="2441"/>
            </a:lvl6pPr>
            <a:lvl7pPr marL="3348076" indent="0">
              <a:buNone/>
              <a:defRPr sz="2441"/>
            </a:lvl7pPr>
            <a:lvl8pPr marL="3906088" indent="0">
              <a:buNone/>
              <a:defRPr sz="2441"/>
            </a:lvl8pPr>
            <a:lvl9pPr marL="4464101" indent="0">
              <a:buNone/>
              <a:defRPr sz="2441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8712" y="2592229"/>
            <a:ext cx="3599431" cy="4802425"/>
          </a:xfrm>
        </p:spPr>
        <p:txBody>
          <a:bodyPr/>
          <a:lstStyle>
            <a:lvl1pPr marL="0" indent="0">
              <a:buNone/>
              <a:defRPr sz="1953"/>
            </a:lvl1pPr>
            <a:lvl2pPr marL="558013" indent="0">
              <a:buNone/>
              <a:defRPr sz="1709"/>
            </a:lvl2pPr>
            <a:lvl3pPr marL="1116025" indent="0">
              <a:buNone/>
              <a:defRPr sz="1465"/>
            </a:lvl3pPr>
            <a:lvl4pPr marL="1674038" indent="0">
              <a:buNone/>
              <a:defRPr sz="1221"/>
            </a:lvl4pPr>
            <a:lvl5pPr marL="2232050" indent="0">
              <a:buNone/>
              <a:defRPr sz="1221"/>
            </a:lvl5pPr>
            <a:lvl6pPr marL="2790063" indent="0">
              <a:buNone/>
              <a:defRPr sz="1221"/>
            </a:lvl6pPr>
            <a:lvl7pPr marL="3348076" indent="0">
              <a:buNone/>
              <a:defRPr sz="1221"/>
            </a:lvl7pPr>
            <a:lvl8pPr marL="3906088" indent="0">
              <a:buNone/>
              <a:defRPr sz="1221"/>
            </a:lvl8pPr>
            <a:lvl9pPr marL="4464101" indent="0">
              <a:buNone/>
              <a:defRPr sz="122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4571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7259" y="460043"/>
            <a:ext cx="9625608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7259" y="2300203"/>
            <a:ext cx="9625608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7259" y="8008709"/>
            <a:ext cx="251102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F11C5-A4CE-43A9-BAF3-DBE2EFF9B614}" type="datetimeFigureOut">
              <a:rPr lang="es-ES" smtClean="0"/>
              <a:t>16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96792" y="8008709"/>
            <a:ext cx="376654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81838" y="8008709"/>
            <a:ext cx="251102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9A3E6-F9EB-4DEE-ACE4-7F865CD2A47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7232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16025" rtl="0" eaLnBrk="1" latinLnBrk="0" hangingPunct="1">
        <a:lnSpc>
          <a:spcPct val="90000"/>
        </a:lnSpc>
        <a:spcBef>
          <a:spcPct val="0"/>
        </a:spcBef>
        <a:buNone/>
        <a:defRPr sz="53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9006" indent="-279006" algn="l" defTabSz="1116025" rtl="0" eaLnBrk="1" latinLnBrk="0" hangingPunct="1">
        <a:lnSpc>
          <a:spcPct val="90000"/>
        </a:lnSpc>
        <a:spcBef>
          <a:spcPts val="1221"/>
        </a:spcBef>
        <a:buFont typeface="Arial" panose="020B0604020202020204" pitchFamily="34" charset="0"/>
        <a:buChar char="•"/>
        <a:defRPr sz="3417" kern="1200">
          <a:solidFill>
            <a:schemeClr val="tx1"/>
          </a:solidFill>
          <a:latin typeface="+mn-lt"/>
          <a:ea typeface="+mn-ea"/>
          <a:cs typeface="+mn-cs"/>
        </a:defRPr>
      </a:lvl1pPr>
      <a:lvl2pPr marL="837019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2pPr>
      <a:lvl3pPr marL="1395032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441" kern="1200">
          <a:solidFill>
            <a:schemeClr val="tx1"/>
          </a:solidFill>
          <a:latin typeface="+mn-lt"/>
          <a:ea typeface="+mn-ea"/>
          <a:cs typeface="+mn-cs"/>
        </a:defRPr>
      </a:lvl3pPr>
      <a:lvl4pPr marL="1953044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4pPr>
      <a:lvl5pPr marL="2511057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5pPr>
      <a:lvl6pPr marL="3069069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6pPr>
      <a:lvl7pPr marL="3627082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7pPr>
      <a:lvl8pPr marL="4185095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8pPr>
      <a:lvl9pPr marL="4743107" indent="-279006" algn="l" defTabSz="1116025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1pPr>
      <a:lvl2pPr marL="558013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2pPr>
      <a:lvl3pPr marL="1116025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3pPr>
      <a:lvl4pPr marL="1674038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4pPr>
      <a:lvl5pPr marL="2232050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5pPr>
      <a:lvl6pPr marL="2790063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6pPr>
      <a:lvl7pPr marL="3348076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7pPr>
      <a:lvl8pPr marL="3906088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8pPr>
      <a:lvl9pPr marL="4464101" algn="l" defTabSz="1116025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833BDC67-1331-65D4-D713-0E42A128A1F1}"/>
              </a:ext>
            </a:extLst>
          </p:cNvPr>
          <p:cNvGrpSpPr/>
          <p:nvPr/>
        </p:nvGrpSpPr>
        <p:grpSpPr>
          <a:xfrm>
            <a:off x="840153" y="693348"/>
            <a:ext cx="9146181" cy="3627033"/>
            <a:chOff x="593018" y="688545"/>
            <a:chExt cx="9146181" cy="3627033"/>
          </a:xfrm>
        </p:grpSpPr>
        <p:pic>
          <p:nvPicPr>
            <p:cNvPr id="4" name="Picture 4">
              <a:extLst>
                <a:ext uri="{FF2B5EF4-FFF2-40B4-BE49-F238E27FC236}">
                  <a16:creationId xmlns:a16="http://schemas.microsoft.com/office/drawing/2014/main" id="{E36DF52E-5388-EB7D-C458-8FEF49234FE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06" t="31988" r="18538" b="17546"/>
            <a:stretch>
              <a:fillRect/>
            </a:stretch>
          </p:blipFill>
          <p:spPr bwMode="auto">
            <a:xfrm>
              <a:off x="5740698" y="962404"/>
              <a:ext cx="3998501" cy="3353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" name="Picture 4">
              <a:extLst>
                <a:ext uri="{FF2B5EF4-FFF2-40B4-BE49-F238E27FC236}">
                  <a16:creationId xmlns:a16="http://schemas.microsoft.com/office/drawing/2014/main" id="{990E8F8D-8949-0678-F8F4-343FAAA6FE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25" t="24682" r="41968" b="33638"/>
            <a:stretch>
              <a:fillRect/>
            </a:stretch>
          </p:blipFill>
          <p:spPr>
            <a:xfrm>
              <a:off x="976077" y="962404"/>
              <a:ext cx="3998501" cy="3353173"/>
            </a:xfrm>
            <a:prstGeom prst="rect">
              <a:avLst/>
            </a:prstGeom>
            <a:noFill/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163C6D76-5995-485B-BEB0-BD0E7E575A11}"/>
                </a:ext>
              </a:extLst>
            </p:cNvPr>
            <p:cNvSpPr txBox="1"/>
            <p:nvPr/>
          </p:nvSpPr>
          <p:spPr>
            <a:xfrm>
              <a:off x="593018" y="688545"/>
              <a:ext cx="7661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>
                  <a:latin typeface="Palatino Linotype" panose="02040502050505030304" pitchFamily="18" charset="0"/>
                </a:rPr>
                <a:t>(a)</a:t>
              </a: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5032D335-4B74-D6CC-E0FF-E4D39AAF0F32}"/>
                </a:ext>
              </a:extLst>
            </p:cNvPr>
            <p:cNvSpPr txBox="1"/>
            <p:nvPr/>
          </p:nvSpPr>
          <p:spPr>
            <a:xfrm>
              <a:off x="5357639" y="688545"/>
              <a:ext cx="7661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>
                  <a:latin typeface="Palatino Linotype" panose="02040502050505030304" pitchFamily="18" charset="0"/>
                </a:rPr>
                <a:t>(b)</a:t>
              </a:r>
            </a:p>
          </p:txBody>
        </p:sp>
      </p:grpSp>
      <p:sp>
        <p:nvSpPr>
          <p:cNvPr id="7" name="CuadroTexto 6">
            <a:extLst>
              <a:ext uri="{FF2B5EF4-FFF2-40B4-BE49-F238E27FC236}">
                <a16:creationId xmlns:a16="http://schemas.microsoft.com/office/drawing/2014/main" id="{3C32A724-1146-9F04-ECDB-1F3341F3E1E2}"/>
              </a:ext>
            </a:extLst>
          </p:cNvPr>
          <p:cNvSpPr txBox="1"/>
          <p:nvPr/>
        </p:nvSpPr>
        <p:spPr>
          <a:xfrm>
            <a:off x="840153" y="4868562"/>
            <a:ext cx="957659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b="1" dirty="0" err="1"/>
              <a:t>Supplementary</a:t>
            </a:r>
            <a:r>
              <a:rPr lang="es-ES" b="1" dirty="0"/>
              <a:t> </a:t>
            </a:r>
            <a:r>
              <a:rPr lang="es-ES" b="1"/>
              <a:t>Figure S1</a:t>
            </a:r>
            <a:r>
              <a:rPr lang="es-ES" b="1" dirty="0"/>
              <a:t>. </a:t>
            </a:r>
            <a:r>
              <a:rPr lang="en-US" b="1" i="1" dirty="0"/>
              <a:t>Fluorescence in situ hybridization (FISH) images from two patients included in the study.</a:t>
            </a:r>
            <a:r>
              <a:rPr lang="en-US" b="1" dirty="0"/>
              <a:t> (a) </a:t>
            </a:r>
            <a:r>
              <a:rPr lang="en-US" dirty="0"/>
              <a:t>FISH using the XL 7q22/7q36 deletion probe (</a:t>
            </a:r>
            <a:r>
              <a:rPr lang="en-US" dirty="0" err="1"/>
              <a:t>MetaSystems</a:t>
            </a:r>
            <a:r>
              <a:rPr lang="en-US" dirty="0"/>
              <a:t>) in patient #2 (Table 2). The results show a normal hybridization pattern with two separate green-red signals, indicating no 7q deletion in the region targeted by the probes. </a:t>
            </a:r>
            <a:r>
              <a:rPr lang="en-US" b="1" dirty="0"/>
              <a:t>(b) </a:t>
            </a:r>
            <a:r>
              <a:rPr lang="en-US" dirty="0"/>
              <a:t>FISH using the t(12;21) ETV6/RUNX1 DF Translocation/Dual Fusion Probe (</a:t>
            </a:r>
            <a:r>
              <a:rPr lang="en-US" dirty="0" err="1"/>
              <a:t>MetaSystems</a:t>
            </a:r>
            <a:r>
              <a:rPr lang="en-US" dirty="0"/>
              <a:t>) in patient #9 (Table 2). The results show a hybridization pattern consistent with iAMP21, characterized by a cluster of several </a:t>
            </a:r>
            <a:r>
              <a:rPr lang="en-US" dirty="0" err="1"/>
              <a:t>closelyn</a:t>
            </a:r>
            <a:r>
              <a:rPr lang="en-US" dirty="0"/>
              <a:t> spaced red signals due to RUNX1 (21q22) amplification. Normal cells exhibit two separated green and red signals.</a:t>
            </a:r>
            <a:r>
              <a:rPr lang="es-ES" dirty="0"/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38162357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1</TotalTime>
  <Words>14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nica Bernal Sanchez</dc:creator>
  <cp:lastModifiedBy>MDPI</cp:lastModifiedBy>
  <cp:revision>5</cp:revision>
  <dcterms:created xsi:type="dcterms:W3CDTF">2025-06-06T12:23:41Z</dcterms:created>
  <dcterms:modified xsi:type="dcterms:W3CDTF">2025-06-16T11:25:49Z</dcterms:modified>
</cp:coreProperties>
</file>